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0" d="100"/>
          <a:sy n="80" d="100"/>
        </p:scale>
        <p:origin x="-180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theme" Target="theme/theme1.xml"/><Relationship Id="rId21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printerSettings" Target="printerSettings/printerSettings1.bin"/><Relationship Id="rId18" Type="http://schemas.openxmlformats.org/officeDocument/2006/relationships/presProps" Target="presProps.xml"/><Relationship Id="rId1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55E7D-5DBF-4543-855A-9D6179B926B8}" type="datetimeFigureOut">
              <a:rPr lang="en-US" smtClean="0"/>
              <a:t>27/0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232B5-C91B-B841-8B9A-0AD2ABD6A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8199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55E7D-5DBF-4543-855A-9D6179B926B8}" type="datetimeFigureOut">
              <a:rPr lang="en-US" smtClean="0"/>
              <a:t>27/0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232B5-C91B-B841-8B9A-0AD2ABD6A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8480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55E7D-5DBF-4543-855A-9D6179B926B8}" type="datetimeFigureOut">
              <a:rPr lang="en-US" smtClean="0"/>
              <a:t>27/0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232B5-C91B-B841-8B9A-0AD2ABD6A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1600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55E7D-5DBF-4543-855A-9D6179B926B8}" type="datetimeFigureOut">
              <a:rPr lang="en-US" smtClean="0"/>
              <a:t>27/0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232B5-C91B-B841-8B9A-0AD2ABD6A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858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55E7D-5DBF-4543-855A-9D6179B926B8}" type="datetimeFigureOut">
              <a:rPr lang="en-US" smtClean="0"/>
              <a:t>27/0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232B5-C91B-B841-8B9A-0AD2ABD6A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4771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55E7D-5DBF-4543-855A-9D6179B926B8}" type="datetimeFigureOut">
              <a:rPr lang="en-US" smtClean="0"/>
              <a:t>27/0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232B5-C91B-B841-8B9A-0AD2ABD6A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452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55E7D-5DBF-4543-855A-9D6179B926B8}" type="datetimeFigureOut">
              <a:rPr lang="en-US" smtClean="0"/>
              <a:t>27/09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232B5-C91B-B841-8B9A-0AD2ABD6A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8017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55E7D-5DBF-4543-855A-9D6179B926B8}" type="datetimeFigureOut">
              <a:rPr lang="en-US" smtClean="0"/>
              <a:t>27/09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232B5-C91B-B841-8B9A-0AD2ABD6A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704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55E7D-5DBF-4543-855A-9D6179B926B8}" type="datetimeFigureOut">
              <a:rPr lang="en-US" smtClean="0"/>
              <a:t>27/09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232B5-C91B-B841-8B9A-0AD2ABD6A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18281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55E7D-5DBF-4543-855A-9D6179B926B8}" type="datetimeFigureOut">
              <a:rPr lang="en-US" smtClean="0"/>
              <a:t>27/0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232B5-C91B-B841-8B9A-0AD2ABD6A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1938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C55E7D-5DBF-4543-855A-9D6179B926B8}" type="datetimeFigureOut">
              <a:rPr lang="en-US" smtClean="0"/>
              <a:t>27/09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232B5-C91B-B841-8B9A-0AD2ABD6A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6242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C55E7D-5DBF-4543-855A-9D6179B926B8}" type="datetimeFigureOut">
              <a:rPr lang="en-US" smtClean="0"/>
              <a:t>27/09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2232B5-C91B-B841-8B9A-0AD2ABD6A6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14125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.pn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.pn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Additional file </a:t>
            </a:r>
            <a:r>
              <a:rPr lang="en-US" dirty="0" smtClean="0"/>
              <a:t>8</a:t>
            </a:r>
            <a:endParaRPr lang="en-US" dirty="0"/>
          </a:p>
        </p:txBody>
      </p:sp>
      <p:pic>
        <p:nvPicPr>
          <p:cNvPr id="3" name="Picture 2" descr="TW1_0.2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1825625"/>
            <a:ext cx="9017000" cy="503237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968750" y="1456293"/>
            <a:ext cx="12230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win pair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6232173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968750" y="122793"/>
            <a:ext cx="1340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win pair 11</a:t>
            </a:r>
            <a:endParaRPr lang="en-US" dirty="0"/>
          </a:p>
        </p:txBody>
      </p:sp>
      <p:pic>
        <p:nvPicPr>
          <p:cNvPr id="2" name="Picture 1" descr="TW11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746124"/>
            <a:ext cx="9017000" cy="6111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300575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968750" y="122793"/>
            <a:ext cx="1340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win pair 12</a:t>
            </a:r>
            <a:endParaRPr lang="en-US" dirty="0"/>
          </a:p>
        </p:txBody>
      </p:sp>
      <p:pic>
        <p:nvPicPr>
          <p:cNvPr id="2" name="Picture 1" descr="TW12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762000"/>
            <a:ext cx="9017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469719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968750" y="122793"/>
            <a:ext cx="1340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win pair 13</a:t>
            </a:r>
            <a:endParaRPr lang="en-US" dirty="0"/>
          </a:p>
        </p:txBody>
      </p:sp>
      <p:pic>
        <p:nvPicPr>
          <p:cNvPr id="2" name="Picture 1" descr="TW13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762000"/>
            <a:ext cx="9017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894681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968750" y="122793"/>
            <a:ext cx="1340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win pair 14</a:t>
            </a:r>
            <a:endParaRPr lang="en-US" dirty="0"/>
          </a:p>
        </p:txBody>
      </p:sp>
      <p:pic>
        <p:nvPicPr>
          <p:cNvPr id="2" name="Picture 1" descr="TW14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746124"/>
            <a:ext cx="9017000" cy="6111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863289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968750" y="122793"/>
            <a:ext cx="1340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win pair 15</a:t>
            </a:r>
            <a:endParaRPr lang="en-US" dirty="0"/>
          </a:p>
        </p:txBody>
      </p:sp>
      <p:pic>
        <p:nvPicPr>
          <p:cNvPr id="2" name="Picture 1" descr="TW15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746124"/>
            <a:ext cx="9017000" cy="6111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212827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968750" y="122793"/>
            <a:ext cx="1340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win pair 16</a:t>
            </a:r>
            <a:endParaRPr lang="en-US" dirty="0"/>
          </a:p>
        </p:txBody>
      </p:sp>
      <p:pic>
        <p:nvPicPr>
          <p:cNvPr id="2" name="Picture 1" descr="TW16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762000"/>
            <a:ext cx="9017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564368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968750" y="106918"/>
            <a:ext cx="12230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win pair 2</a:t>
            </a:r>
            <a:endParaRPr lang="en-US" dirty="0"/>
          </a:p>
        </p:txBody>
      </p:sp>
      <p:pic>
        <p:nvPicPr>
          <p:cNvPr id="4" name="Picture 3" descr="TW2_0.2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603251"/>
            <a:ext cx="9017000" cy="61199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902595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968750" y="122793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win pair 4</a:t>
            </a:r>
            <a:endParaRPr lang="en-US" dirty="0"/>
          </a:p>
        </p:txBody>
      </p:sp>
      <p:pic>
        <p:nvPicPr>
          <p:cNvPr id="6" name="Picture 5" descr="TW4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698500"/>
            <a:ext cx="8875059" cy="6159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791606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968750" y="122793"/>
            <a:ext cx="12230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win pair 5</a:t>
            </a:r>
          </a:p>
        </p:txBody>
      </p:sp>
      <p:pic>
        <p:nvPicPr>
          <p:cNvPr id="2" name="Picture 1" descr="TW5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762000"/>
            <a:ext cx="9017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603378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968750" y="122793"/>
            <a:ext cx="12230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win pair 6</a:t>
            </a:r>
            <a:endParaRPr lang="en-US" dirty="0"/>
          </a:p>
        </p:txBody>
      </p:sp>
      <p:pic>
        <p:nvPicPr>
          <p:cNvPr id="2" name="Picture 1" descr="TW6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746124"/>
            <a:ext cx="9017000" cy="6111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217203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968750" y="122793"/>
            <a:ext cx="12230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win pair 7</a:t>
            </a:r>
            <a:endParaRPr lang="en-US" dirty="0"/>
          </a:p>
        </p:txBody>
      </p:sp>
      <p:pic>
        <p:nvPicPr>
          <p:cNvPr id="2" name="Picture 1" descr="TW7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762000"/>
            <a:ext cx="9017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8015729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968750" y="122793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win pair 8</a:t>
            </a:r>
            <a:endParaRPr lang="en-US" dirty="0"/>
          </a:p>
        </p:txBody>
      </p:sp>
      <p:pic>
        <p:nvPicPr>
          <p:cNvPr id="2" name="Picture 1" descr="TW8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746124"/>
            <a:ext cx="9017000" cy="6111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451441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968750" y="122793"/>
            <a:ext cx="12230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win pair 9</a:t>
            </a:r>
            <a:endParaRPr lang="en-US" dirty="0"/>
          </a:p>
        </p:txBody>
      </p:sp>
      <p:pic>
        <p:nvPicPr>
          <p:cNvPr id="2" name="Picture 1" descr="TW9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762000"/>
            <a:ext cx="9017000" cy="609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0262291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968750" y="122793"/>
            <a:ext cx="1340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win pair 10</a:t>
            </a:r>
            <a:endParaRPr lang="en-US" dirty="0"/>
          </a:p>
        </p:txBody>
      </p:sp>
      <p:pic>
        <p:nvPicPr>
          <p:cNvPr id="2" name="Picture 1" descr="TW10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" y="746124"/>
            <a:ext cx="9017000" cy="61118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4379303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48</Words>
  <Application>Microsoft Macintosh PowerPoint</Application>
  <PresentationFormat>On-screen Show (4:3)</PresentationFormat>
  <Paragraphs>16</Paragraphs>
  <Slides>1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6" baseType="lpstr">
      <vt:lpstr>Office Theme</vt:lpstr>
      <vt:lpstr>Additional file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urdoch Childrens Research Institut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dditional file 8</dc:title>
  <dc:creator>Namitha Mohandas</dc:creator>
  <cp:lastModifiedBy>Namitha Mohandas</cp:lastModifiedBy>
  <cp:revision>14</cp:revision>
  <dcterms:created xsi:type="dcterms:W3CDTF">2017-09-25T04:32:55Z</dcterms:created>
  <dcterms:modified xsi:type="dcterms:W3CDTF">2017-09-27T03:14:32Z</dcterms:modified>
</cp:coreProperties>
</file>